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8" d="100"/>
          <a:sy n="88" d="100"/>
        </p:scale>
        <p:origin x="3630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2567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4052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2889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664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491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9228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8855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7142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783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1666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969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9C6B4-BA9E-4E8D-81F1-70030E288151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A7FC9-33FF-4C77-B024-AB5E0D3FD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933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8948581"/>
              </p:ext>
            </p:extLst>
          </p:nvPr>
        </p:nvGraphicFramePr>
        <p:xfrm>
          <a:off x="332656" y="3059832"/>
          <a:ext cx="5550847" cy="33782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80120"/>
                <a:gridCol w="1405255"/>
                <a:gridCol w="1441768"/>
                <a:gridCol w="1623704"/>
              </a:tblGrid>
              <a:tr h="370840">
                <a:tc>
                  <a:txBody>
                    <a:bodyPr/>
                    <a:lstStyle/>
                    <a:p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yburide vs. insulin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formin vs. insulin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formin</a:t>
                      </a:r>
                      <a:r>
                        <a:rPr lang="en-GB" sz="105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vs. glyburide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BS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2.73, p=0.006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BS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15, p=0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bA1c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83, p=0.40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otal pregnancy weight</a:t>
                      </a:r>
                      <a:r>
                        <a:rPr lang="en-GB" sz="105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gain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15, p=0.13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ate weight gain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ot reported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ot</a:t>
                      </a:r>
                      <a:r>
                        <a:rPr lang="en-GB" sz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reported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irth weight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2.43;  p=0.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0.24, p=0.81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crosomia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27, p=0.20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.00, p=0.32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05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A</a:t>
                      </a:r>
                      <a:endParaRPr lang="en-GB" sz="105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78, p=0.44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&lt; 5 studies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32656" y="6881772"/>
            <a:ext cx="36860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xpressed as Egger’s test values and associated p value.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2656" y="2483768"/>
            <a:ext cx="1947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4 Table – Egger’s test table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7547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15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Jane Adkins</cp:lastModifiedBy>
  <cp:revision>6</cp:revision>
  <cp:lastPrinted>2019-07-30T07:55:57Z</cp:lastPrinted>
  <dcterms:created xsi:type="dcterms:W3CDTF">2019-07-25T07:28:20Z</dcterms:created>
  <dcterms:modified xsi:type="dcterms:W3CDTF">2020-02-20T08:09:51Z</dcterms:modified>
</cp:coreProperties>
</file>